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F436FA-4726-45CA-84B0-7CAC53B7290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8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1DA46B7-DA46-4621-85A4-23105606B87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73AF08-EE23-4A68-8D08-F349C255F62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F34BAF-C549-44A1-93B2-0BB3C56BA1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89C8EB-E8BD-42FE-BFB7-011F9DC8DE6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3ED780-B756-4A1B-81A2-A88886C94FC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6183ED-D75C-4539-ADE9-DDB70D5839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700F47-6974-4A3C-8FB4-2C63ACD798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C257B0-E367-492C-B137-E2376045F6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29BA2F-8458-4AC2-A051-6A9D267193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049030-6DF4-47E4-AD2F-5B89BFF1DC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E9ED60-0E06-4C9A-80B2-CAFCC598F6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BDFA9C-F58E-44C5-814E-253F0F778E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4940AE-6592-4397-B4CE-E2D1240A14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316F68-B756-4115-9E09-0C531904AF3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Chart 3" descr=""/>
          <p:cNvPicPr/>
          <p:nvPr/>
        </p:nvPicPr>
        <p:blipFill>
          <a:blip r:embed="rId1"/>
          <a:stretch/>
        </p:blipFill>
        <p:spPr>
          <a:xfrm>
            <a:off x="798480" y="4127400"/>
            <a:ext cx="5888160" cy="3310200"/>
          </a:xfrm>
          <a:prstGeom prst="rect">
            <a:avLst/>
          </a:prstGeom>
          <a:ln w="0">
            <a:noFill/>
          </a:ln>
        </p:spPr>
      </p:pic>
      <p:grpSp>
        <p:nvGrpSpPr>
          <p:cNvPr id="49" name="Group 35"/>
          <p:cNvGrpSpPr/>
          <p:nvPr/>
        </p:nvGrpSpPr>
        <p:grpSpPr>
          <a:xfrm>
            <a:off x="714240" y="571680"/>
            <a:ext cx="5911920" cy="3462120"/>
            <a:chOff x="714240" y="571680"/>
            <a:chExt cx="5911920" cy="3462120"/>
          </a:xfrm>
        </p:grpSpPr>
        <p:pic>
          <p:nvPicPr>
            <p:cNvPr id="50" name="Chart 4" descr=""/>
            <p:cNvPicPr/>
            <p:nvPr/>
          </p:nvPicPr>
          <p:blipFill>
            <a:blip r:embed="rId2"/>
            <a:stretch/>
          </p:blipFill>
          <p:spPr>
            <a:xfrm>
              <a:off x="714240" y="571680"/>
              <a:ext cx="5911920" cy="3462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TextBox 6"/>
            <p:cNvSpPr/>
            <p:nvPr/>
          </p:nvSpPr>
          <p:spPr>
            <a:xfrm>
              <a:off x="3157200" y="1027080"/>
              <a:ext cx="734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CF-7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2" name="Group 11"/>
            <p:cNvGrpSpPr/>
            <p:nvPr/>
          </p:nvGrpSpPr>
          <p:grpSpPr>
            <a:xfrm>
              <a:off x="4183920" y="2936160"/>
              <a:ext cx="286920" cy="459360"/>
              <a:chOff x="4183920" y="2936160"/>
              <a:chExt cx="286920" cy="459360"/>
            </a:xfrm>
          </p:grpSpPr>
          <p:sp>
            <p:nvSpPr>
              <p:cNvPr id="53" name="TextBox 12"/>
              <p:cNvSpPr/>
              <p:nvPr/>
            </p:nvSpPr>
            <p:spPr>
              <a:xfrm>
                <a:off x="4183920" y="2936160"/>
                <a:ext cx="28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TextBox 13"/>
              <p:cNvSpPr/>
              <p:nvPr/>
            </p:nvSpPr>
            <p:spPr>
              <a:xfrm>
                <a:off x="4183920" y="3058200"/>
                <a:ext cx="28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5" name="Group 19"/>
            <p:cNvGrpSpPr/>
            <p:nvPr/>
          </p:nvGrpSpPr>
          <p:grpSpPr>
            <a:xfrm>
              <a:off x="5230440" y="718920"/>
              <a:ext cx="286920" cy="459360"/>
              <a:chOff x="5230440" y="718920"/>
              <a:chExt cx="286920" cy="459360"/>
            </a:xfrm>
          </p:grpSpPr>
          <p:sp>
            <p:nvSpPr>
              <p:cNvPr id="56" name="TextBox 17"/>
              <p:cNvSpPr/>
              <p:nvPr/>
            </p:nvSpPr>
            <p:spPr>
              <a:xfrm>
                <a:off x="5230440" y="718920"/>
                <a:ext cx="28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TextBox 18"/>
              <p:cNvSpPr/>
              <p:nvPr/>
            </p:nvSpPr>
            <p:spPr>
              <a:xfrm>
                <a:off x="5230440" y="840960"/>
                <a:ext cx="28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8" name="Group 20"/>
            <p:cNvGrpSpPr/>
            <p:nvPr/>
          </p:nvGrpSpPr>
          <p:grpSpPr>
            <a:xfrm>
              <a:off x="4710240" y="2306520"/>
              <a:ext cx="286920" cy="459360"/>
              <a:chOff x="4710240" y="2306520"/>
              <a:chExt cx="286920" cy="459360"/>
            </a:xfrm>
          </p:grpSpPr>
          <p:sp>
            <p:nvSpPr>
              <p:cNvPr id="59" name="TextBox 21"/>
              <p:cNvSpPr/>
              <p:nvPr/>
            </p:nvSpPr>
            <p:spPr>
              <a:xfrm>
                <a:off x="4710240" y="2306520"/>
                <a:ext cx="28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TextBox 22"/>
              <p:cNvSpPr/>
              <p:nvPr/>
            </p:nvSpPr>
            <p:spPr>
              <a:xfrm>
                <a:off x="4710240" y="2428560"/>
                <a:ext cx="28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1" name="Group 23"/>
            <p:cNvGrpSpPr/>
            <p:nvPr/>
          </p:nvGrpSpPr>
          <p:grpSpPr>
            <a:xfrm>
              <a:off x="4816800" y="2563560"/>
              <a:ext cx="286920" cy="459360"/>
              <a:chOff x="4816800" y="2563560"/>
              <a:chExt cx="286920" cy="459360"/>
            </a:xfrm>
          </p:grpSpPr>
          <p:sp>
            <p:nvSpPr>
              <p:cNvPr id="62" name="TextBox 24"/>
              <p:cNvSpPr/>
              <p:nvPr/>
            </p:nvSpPr>
            <p:spPr>
              <a:xfrm>
                <a:off x="4816800" y="2563560"/>
                <a:ext cx="28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TextBox 25"/>
              <p:cNvSpPr/>
              <p:nvPr/>
            </p:nvSpPr>
            <p:spPr>
              <a:xfrm>
                <a:off x="4816800" y="2685600"/>
                <a:ext cx="28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4" name="Group 26"/>
            <p:cNvGrpSpPr/>
            <p:nvPr/>
          </p:nvGrpSpPr>
          <p:grpSpPr>
            <a:xfrm>
              <a:off x="5342400" y="955080"/>
              <a:ext cx="286920" cy="459360"/>
              <a:chOff x="5342400" y="955080"/>
              <a:chExt cx="286920" cy="459360"/>
            </a:xfrm>
          </p:grpSpPr>
          <p:sp>
            <p:nvSpPr>
              <p:cNvPr id="65" name="TextBox 27"/>
              <p:cNvSpPr/>
              <p:nvPr/>
            </p:nvSpPr>
            <p:spPr>
              <a:xfrm>
                <a:off x="5342400" y="955080"/>
                <a:ext cx="28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TextBox 28"/>
              <p:cNvSpPr/>
              <p:nvPr/>
            </p:nvSpPr>
            <p:spPr>
              <a:xfrm>
                <a:off x="5342400" y="1077120"/>
                <a:ext cx="28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7" name="Group 29"/>
            <p:cNvGrpSpPr/>
            <p:nvPr/>
          </p:nvGrpSpPr>
          <p:grpSpPr>
            <a:xfrm>
              <a:off x="5524920" y="2948400"/>
              <a:ext cx="286920" cy="459360"/>
              <a:chOff x="5524920" y="2948400"/>
              <a:chExt cx="286920" cy="459360"/>
            </a:xfrm>
          </p:grpSpPr>
          <p:sp>
            <p:nvSpPr>
              <p:cNvPr id="68" name="TextBox 30"/>
              <p:cNvSpPr/>
              <p:nvPr/>
            </p:nvSpPr>
            <p:spPr>
              <a:xfrm>
                <a:off x="5524920" y="2948400"/>
                <a:ext cx="28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TextBox 31"/>
              <p:cNvSpPr/>
              <p:nvPr/>
            </p:nvSpPr>
            <p:spPr>
              <a:xfrm>
                <a:off x="5524920" y="3070440"/>
                <a:ext cx="28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0" name="TextBox 33"/>
            <p:cNvSpPr/>
            <p:nvPr/>
          </p:nvSpPr>
          <p:spPr>
            <a:xfrm>
              <a:off x="5426280" y="3196800"/>
              <a:ext cx="286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1" name="TextBox 5"/>
          <p:cNvSpPr/>
          <p:nvPr/>
        </p:nvSpPr>
        <p:spPr>
          <a:xfrm>
            <a:off x="39240" y="81000"/>
            <a:ext cx="70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0"/>
          <p:cNvSpPr/>
          <p:nvPr/>
        </p:nvSpPr>
        <p:spPr>
          <a:xfrm>
            <a:off x="4813200" y="4854600"/>
            <a:ext cx="287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0"/>
          <p:cNvSpPr/>
          <p:nvPr/>
        </p:nvSpPr>
        <p:spPr>
          <a:xfrm>
            <a:off x="4994280" y="5000760"/>
            <a:ext cx="192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30"/>
          <p:cNvSpPr/>
          <p:nvPr/>
        </p:nvSpPr>
        <p:spPr>
          <a:xfrm>
            <a:off x="5089680" y="5181480"/>
            <a:ext cx="191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19"/>
          <p:cNvSpPr/>
          <p:nvPr/>
        </p:nvSpPr>
        <p:spPr>
          <a:xfrm>
            <a:off x="455760" y="403200"/>
            <a:ext cx="34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19"/>
          <p:cNvSpPr/>
          <p:nvPr/>
        </p:nvSpPr>
        <p:spPr>
          <a:xfrm>
            <a:off x="455760" y="3965400"/>
            <a:ext cx="342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Rectangle 33"/>
          <p:cNvSpPr/>
          <p:nvPr/>
        </p:nvSpPr>
        <p:spPr>
          <a:xfrm flipH="1">
            <a:off x="202320" y="7572960"/>
            <a:ext cx="632628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Figure S2  Activation of interferon signaling pathway in parental MCF-7 and AI-resistan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MCF-7:5C cells in response to INF-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a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) MCF-7 (upper panel) and MCF-7:5C (lower panel) cells were incubated with IFN-α (1000 U/ml) for the indicated time points. The cell extracts were examined by Western blotting using anti-PLSCR1, anti-IFITM1, anti-STAT1, anti-STAT2, and anti-b-actin. The protein levels were quantified using the ImageJ software (downloaded from NIH website) and normalized as the ratio relate to β-actin. *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&lt; 0.05 or **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&lt; 0.01 versus control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30"/>
          <p:cNvSpPr/>
          <p:nvPr/>
        </p:nvSpPr>
        <p:spPr>
          <a:xfrm>
            <a:off x="4902120" y="5257800"/>
            <a:ext cx="192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32"/>
          <p:cNvSpPr/>
          <p:nvPr/>
        </p:nvSpPr>
        <p:spPr>
          <a:xfrm>
            <a:off x="5894640" y="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oi et al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08T22:57:44Z</dcterms:created>
  <dc:creator>Windows User</dc:creator>
  <dc:description/>
  <dc:language>en-US</dc:language>
  <cp:lastModifiedBy>Windows User</cp:lastModifiedBy>
  <dcterms:modified xsi:type="dcterms:W3CDTF">2014-10-08T22:58:10Z</dcterms:modified>
  <cp:revision>1</cp:revision>
  <dc:subject/>
  <dc:title>PowerPoint Presentation</dc:title>
</cp:coreProperties>
</file>